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12038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02723-6D4D-4A30-82AD-B3171C2697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4970F-8D4E-430C-9E99-3EAF7BB773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DD6E9-F452-4F95-A90F-7C127913F1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E3B40-C199-4703-A195-7ACC7FBC43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71811-0364-4585-8A91-DCFD155315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F373B-01A4-4AE9-8ED6-9EB037B635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11191-72AB-4CA8-A361-B5A7CC4CA5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140A7-A12B-44C6-88A3-8FFC705C58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2E4E1-228E-4EA7-8BD3-CFA7C8E18D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38324-E5E4-430D-BBA8-F575ED35C2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54ED4-9183-4D1E-BB58-165FCA6FA1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07EE3-E1DD-4B3E-92F4-7348CD9B5E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2B668C-404E-476C-89C1-06EE8D76DCE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86280" y="213480"/>
            <a:ext cx="4023000" cy="6440760"/>
            <a:chOff x="386280" y="213480"/>
            <a:chExt cx="4023000" cy="6440760"/>
          </a:xfrm>
        </p:grpSpPr>
        <p:grpSp>
          <p:nvGrpSpPr>
            <p:cNvPr id="42" name=""/>
            <p:cNvGrpSpPr/>
            <p:nvPr/>
          </p:nvGrpSpPr>
          <p:grpSpPr>
            <a:xfrm>
              <a:off x="386280" y="213480"/>
              <a:ext cx="3891240" cy="6349680"/>
              <a:chOff x="386280" y="213480"/>
              <a:chExt cx="3891240" cy="6349680"/>
            </a:xfrm>
          </p:grpSpPr>
          <p:sp>
            <p:nvSpPr>
              <p:cNvPr id="43" name=""/>
              <p:cNvSpPr/>
              <p:nvPr/>
            </p:nvSpPr>
            <p:spPr>
              <a:xfrm>
                <a:off x="386280" y="2550960"/>
                <a:ext cx="168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554400" y="592200"/>
                <a:ext cx="0" cy="1958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54400" y="59220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639000" y="402840"/>
                <a:ext cx="0" cy="189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639000" y="402840"/>
                <a:ext cx="2158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2797920" y="29736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797920" y="297360"/>
                <a:ext cx="536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3335040" y="24444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335040" y="2448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335040" y="29736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335040" y="371160"/>
                <a:ext cx="442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797920" y="40284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797920" y="507960"/>
                <a:ext cx="810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639000" y="592200"/>
                <a:ext cx="0" cy="15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39000" y="750240"/>
                <a:ext cx="1832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2471400" y="63396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471400" y="634320"/>
                <a:ext cx="1295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2471400" y="750240"/>
                <a:ext cx="0" cy="84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471400" y="834480"/>
                <a:ext cx="600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V="1">
                <a:off x="3071880" y="7711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071880" y="771480"/>
                <a:ext cx="452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071880" y="83448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071880" y="897480"/>
                <a:ext cx="368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554400" y="1191960"/>
                <a:ext cx="0" cy="1358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54400" y="1192320"/>
                <a:ext cx="336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891720" y="108684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891720" y="1087200"/>
                <a:ext cx="84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975960" y="103392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975960" y="1034280"/>
                <a:ext cx="326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975960" y="108720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975960" y="1161000"/>
                <a:ext cx="7581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891720" y="1192320"/>
                <a:ext cx="0" cy="168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891720" y="1361160"/>
                <a:ext cx="305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1197000" y="129744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197000" y="1297800"/>
                <a:ext cx="105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197000" y="136116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1197000" y="1424160"/>
                <a:ext cx="95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54400" y="2550960"/>
                <a:ext cx="0" cy="2032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54400" y="4583520"/>
                <a:ext cx="95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649440" y="3793320"/>
                <a:ext cx="0" cy="789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649440" y="3793320"/>
                <a:ext cx="147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797040" y="2824200"/>
                <a:ext cx="0" cy="968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797040" y="282456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V="1">
                <a:off x="839160" y="2529360"/>
                <a:ext cx="0" cy="2948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839160" y="252972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 flipV="1">
                <a:off x="955080" y="2277000"/>
                <a:ext cx="0" cy="2527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955080" y="2277000"/>
                <a:ext cx="420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V="1">
                <a:off x="1375920" y="2098440"/>
                <a:ext cx="0" cy="178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375920" y="209844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 flipV="1">
                <a:off x="1418400" y="1834560"/>
                <a:ext cx="0" cy="263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418400" y="1834920"/>
                <a:ext cx="315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 flipV="1">
                <a:off x="1734480" y="1624320"/>
                <a:ext cx="0" cy="210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734480" y="1624320"/>
                <a:ext cx="431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 flipV="1">
                <a:off x="2166120" y="156060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166120" y="1560960"/>
                <a:ext cx="41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166120" y="16243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166120" y="1687680"/>
                <a:ext cx="168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734480" y="1834920"/>
                <a:ext cx="0" cy="273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734480" y="2108520"/>
                <a:ext cx="10000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734560" y="199260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734560" y="1992960"/>
                <a:ext cx="389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3124440" y="1887480"/>
                <a:ext cx="0" cy="1047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124440" y="1887840"/>
                <a:ext cx="358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3482640" y="18241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482640" y="18244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482640" y="188784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482640" y="1950480"/>
                <a:ext cx="399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124440" y="199296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124440" y="20876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734560" y="2108520"/>
                <a:ext cx="0" cy="1051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734560" y="2214000"/>
                <a:ext cx="52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418400" y="2098440"/>
                <a:ext cx="0" cy="305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1418400" y="2403720"/>
                <a:ext cx="495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1913400" y="235080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1913400" y="2351160"/>
                <a:ext cx="178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1913400" y="24037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1913400" y="2477160"/>
                <a:ext cx="1116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375920" y="2277000"/>
                <a:ext cx="0" cy="3369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1375920" y="2614320"/>
                <a:ext cx="726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955080" y="2529720"/>
                <a:ext cx="0" cy="273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955080" y="2803680"/>
                <a:ext cx="484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1439280" y="274068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1439280" y="274068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439280" y="280368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1439280" y="2877480"/>
                <a:ext cx="210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839160" y="2824560"/>
                <a:ext cx="0" cy="263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839160" y="308808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912600" y="3003840"/>
                <a:ext cx="0" cy="842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912600" y="3003840"/>
                <a:ext cx="22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912600" y="308808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912600" y="31406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797040" y="3793320"/>
                <a:ext cx="0" cy="105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797040" y="484668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870480" y="4498920"/>
                <a:ext cx="0" cy="347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870480" y="4499280"/>
                <a:ext cx="42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912600" y="4267080"/>
                <a:ext cx="0" cy="2314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912600" y="4267440"/>
                <a:ext cx="126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 flipV="1">
                <a:off x="1039320" y="3919680"/>
                <a:ext cx="0" cy="347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039320" y="3920040"/>
                <a:ext cx="52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 flipV="1">
                <a:off x="1091880" y="3719880"/>
                <a:ext cx="0" cy="2001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091880" y="3719880"/>
                <a:ext cx="284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V="1">
                <a:off x="1375920" y="3456720"/>
                <a:ext cx="0" cy="262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375920" y="3456720"/>
                <a:ext cx="231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V="1">
                <a:off x="1607760" y="334044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607760" y="3340800"/>
                <a:ext cx="738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 flipV="1">
                <a:off x="1681920" y="32673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1681920" y="326736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681920" y="334080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1681920" y="340416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1607760" y="3456720"/>
                <a:ext cx="0" cy="136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1607760" y="3593520"/>
                <a:ext cx="22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1829160" y="354024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1829160" y="3540600"/>
                <a:ext cx="6001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829160" y="35935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1829160" y="3667320"/>
                <a:ext cx="947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375920" y="3719880"/>
                <a:ext cx="0" cy="2736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375920" y="3993840"/>
                <a:ext cx="284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 flipV="1">
                <a:off x="1660680" y="3856680"/>
                <a:ext cx="0" cy="136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1660680" y="3856680"/>
                <a:ext cx="526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 flipV="1">
                <a:off x="2187360" y="380376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187360" y="380412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187360" y="38566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187360" y="3930480"/>
                <a:ext cx="210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660680" y="399384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1660680" y="4120200"/>
                <a:ext cx="4312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2092320" y="406692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092320" y="4067280"/>
                <a:ext cx="2210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092320" y="412020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092320" y="4194000"/>
                <a:ext cx="621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091880" y="3920040"/>
                <a:ext cx="0" cy="410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1091880" y="4330800"/>
                <a:ext cx="108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1039320" y="4267440"/>
                <a:ext cx="0" cy="3682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1039320" y="4636080"/>
                <a:ext cx="83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 flipV="1">
                <a:off x="1123200" y="4519800"/>
                <a:ext cx="0" cy="1155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1123200" y="4520160"/>
                <a:ext cx="734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V="1">
                <a:off x="1197000" y="445680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1197000" y="445716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1197000" y="45201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197000" y="4593960"/>
                <a:ext cx="294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1123200" y="4636080"/>
                <a:ext cx="0" cy="15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1123200" y="4794120"/>
                <a:ext cx="2527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 flipV="1">
                <a:off x="1375920" y="472032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375920" y="4720320"/>
                <a:ext cx="6634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375920" y="47941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375920" y="4857480"/>
                <a:ext cx="610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912600" y="4499280"/>
                <a:ext cx="0" cy="484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912600" y="4983480"/>
                <a:ext cx="684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870480" y="4846680"/>
                <a:ext cx="0" cy="4104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870480" y="525744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965160" y="5173200"/>
                <a:ext cx="0" cy="838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965160" y="5173560"/>
                <a:ext cx="31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997200" y="5120280"/>
                <a:ext cx="0" cy="52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997200" y="512064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997200" y="517356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997200" y="5247000"/>
                <a:ext cx="2102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965160" y="5257440"/>
                <a:ext cx="0" cy="189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965160" y="5446800"/>
                <a:ext cx="6109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V="1">
                <a:off x="1576440" y="5383800"/>
                <a:ext cx="0" cy="626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1576440" y="538380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576440" y="544680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1576440" y="5510160"/>
                <a:ext cx="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649440" y="4583520"/>
                <a:ext cx="0" cy="1474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649440" y="6057720"/>
                <a:ext cx="347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997200" y="5773320"/>
                <a:ext cx="0" cy="2840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997200" y="5773680"/>
                <a:ext cx="2948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V="1">
                <a:off x="1292040" y="5646600"/>
                <a:ext cx="0" cy="126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1292040" y="5646960"/>
                <a:ext cx="14425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1292040" y="57736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1292040" y="5847120"/>
                <a:ext cx="49464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V="1">
                <a:off x="1787040" y="5773680"/>
                <a:ext cx="0" cy="7344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787040" y="5773680"/>
                <a:ext cx="4950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787040" y="5847120"/>
                <a:ext cx="0" cy="63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787040" y="5910480"/>
                <a:ext cx="3582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997200" y="6057720"/>
                <a:ext cx="0" cy="3157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997200" y="6373800"/>
                <a:ext cx="3999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1397160" y="6194520"/>
                <a:ext cx="0" cy="178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397160" y="6194880"/>
                <a:ext cx="946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 flipV="1">
                <a:off x="1491840" y="6036840"/>
                <a:ext cx="0" cy="157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491840" y="6036840"/>
                <a:ext cx="28440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491840" y="6194880"/>
                <a:ext cx="0" cy="1260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491840" y="6320880"/>
                <a:ext cx="126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 flipV="1">
                <a:off x="1618560" y="6225840"/>
                <a:ext cx="0" cy="9468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618560" y="6226200"/>
                <a:ext cx="1893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 flipV="1">
                <a:off x="1807920" y="6173280"/>
                <a:ext cx="0" cy="522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807920" y="6173640"/>
                <a:ext cx="2088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1807920" y="6226200"/>
                <a:ext cx="0" cy="7380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000" bIns="27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1807920" y="6300360"/>
                <a:ext cx="4107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1618560" y="6320880"/>
                <a:ext cx="0" cy="11592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1618560" y="6437160"/>
                <a:ext cx="46332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1397160" y="6373800"/>
                <a:ext cx="0" cy="18936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1397160" y="6563160"/>
                <a:ext cx="115560" cy="0"/>
              </a:xfrm>
              <a:prstGeom prst="line">
                <a:avLst/>
              </a:prstGeom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3369960" y="21348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3g578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3812040" y="33948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2g42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3651120" y="47628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1g359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3801960" y="60300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253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3561480" y="73980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738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3476880" y="866160"/>
                <a:ext cx="46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At1g18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1352520" y="1002960"/>
                <a:ext cx="52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Os09g325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1775520" y="112968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Bd4g343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1352520" y="1266120"/>
                <a:ext cx="52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Os08g413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3" name=""/>
            <p:cNvSpPr/>
            <p:nvPr/>
          </p:nvSpPr>
          <p:spPr>
            <a:xfrm>
              <a:off x="1333440" y="13928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08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259360" y="15296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2g476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376360" y="16560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527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533040" y="17928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9g33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3925440" y="19195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348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175560" y="20563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8g424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2829960" y="21826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415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143440" y="23194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5g012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071520" y="24458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399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139840" y="25830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509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489680" y="271980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4g282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692000" y="28461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5g066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1160280" y="29829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485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949680" y="310968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073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827720" y="32464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9g298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818720" y="33724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329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480760" y="35096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8g380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818800" y="363600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3g388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237040" y="37731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3g519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439360" y="389916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099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364840" y="403596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3g129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755440" y="41626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691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213640" y="429912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101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349640" y="442584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689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542240" y="456264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6g16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076480" y="46890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262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019960" y="4825800"/>
              <a:ext cx="755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At4g34530_CIB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634400" y="495252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3g236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048320" y="50893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11g255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249200" y="521532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4g195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627560" y="535248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1g687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618920" y="547884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2g586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771640" y="56160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5g626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319120" y="57420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4g365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181960" y="587916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2g18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816920" y="60055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7g095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1880280" y="6142320"/>
              <a:ext cx="52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Os03g588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260440" y="62686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546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123280" y="6405480"/>
              <a:ext cx="48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Bd1g050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1549800" y="6532200"/>
              <a:ext cx="465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At1g596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"/>
          <p:cNvSpPr/>
          <p:nvPr/>
        </p:nvSpPr>
        <p:spPr>
          <a:xfrm>
            <a:off x="1356120" y="52959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584440" y="241200"/>
            <a:ext cx="282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250000" y="5796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851560" y="6764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2894400" y="18241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1219680" y="26449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521440" y="19368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3107160" y="1332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1567440" y="56894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5003640" y="333360"/>
            <a:ext cx="259272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00 datase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3T09:04:27Z</dcterms:created>
  <dc:creator>baileyp</dc:creator>
  <dc:description/>
  <dc:language>en-US</dc:language>
  <cp:lastModifiedBy>Janet Higgins</cp:lastModifiedBy>
  <dcterms:modified xsi:type="dcterms:W3CDTF">2010-01-06T11:57:39Z</dcterms:modified>
  <cp:revision>93</cp:revision>
  <dc:subject/>
  <dc:title>Slide 1</dc:title>
</cp:coreProperties>
</file>